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10961432-FAD1-449E-B2E3-9BE02AD9BECA}"/>
    <pc:docChg chg="modSld">
      <pc:chgData name="Semertzidou, Anysia" userId="a7f71f62-1794-4728-88f7-f0b545a7c8aa" providerId="ADAL" clId="{10961432-FAD1-449E-B2E3-9BE02AD9BECA}" dt="2025-10-30T16:17:15.064" v="4" actId="1076"/>
      <pc:docMkLst>
        <pc:docMk/>
      </pc:docMkLst>
      <pc:sldChg chg="addSp modSp mod">
        <pc:chgData name="Semertzidou, Anysia" userId="a7f71f62-1794-4728-88f7-f0b545a7c8aa" providerId="ADAL" clId="{10961432-FAD1-449E-B2E3-9BE02AD9BECA}" dt="2025-10-30T16:17:15.064" v="4" actId="1076"/>
        <pc:sldMkLst>
          <pc:docMk/>
          <pc:sldMk cId="4254437795" sldId="256"/>
        </pc:sldMkLst>
        <pc:spChg chg="add mod">
          <ac:chgData name="Semertzidou, Anysia" userId="a7f71f62-1794-4728-88f7-f0b545a7c8aa" providerId="ADAL" clId="{10961432-FAD1-449E-B2E3-9BE02AD9BECA}" dt="2025-10-30T16:17:15.064" v="4" actId="1076"/>
          <ac:spMkLst>
            <pc:docMk/>
            <pc:sldMk cId="4254437795" sldId="256"/>
            <ac:spMk id="3" creationId="{89DEA865-87DC-5CBF-DEC5-18ACFB7D3E5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1BE956-611A-D750-B818-A7BD080104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71C820-5B08-95A9-82A8-45FA6958E1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D68DC1-894A-FD24-A106-88B97A148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9867A-0193-4CE5-BA68-ED03E551F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7609CA-926F-7FA4-368F-E96F2C4209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788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6392E-7C62-B273-F9FD-85399E1FCF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6F432F-41D5-9623-2765-D48127DDF5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F790F-8995-0005-0B5E-910413091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651E97-61EE-0AB9-7991-45ACF10C1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8D3148-2439-0993-0105-55BD89030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986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6277E9-DDB3-9CA8-2464-86AB52F453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1DCEC0-D31C-2C69-310B-2C6F1D611F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B54133-0748-E372-9C6D-F8F4284E6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B27B40-3BCB-EEDB-3679-888E768B9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8C26C4-A1C6-F3F5-A308-D686B8E6A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9271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2B7FBA-11ED-9F78-2C12-AD2541444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9D4FDE-6AFE-00B2-11AC-69BCFDC618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881211-DB2D-48DD-0414-F17991538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EA1A30-92D4-7CD1-79E5-A3FD64E97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1CF45-1AE5-CA83-558D-3109F9187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277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76A369-100D-B528-16E9-1014F0396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DD4CF4-1058-9AA7-AB8D-71EEB6D0F0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802CC9-16E4-17B8-6078-7EE9B540F0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E46364-9428-B9BC-A7CB-1504B23CA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4EDFC1-A1E1-4597-36DC-CE8FC4ECF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4452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EB932-DBBA-CF16-9F13-7C45E6226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F68712-0E84-7775-1B17-120FB6E3EF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A6C4ED-97E8-3370-30B3-3D62319EC2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808F04-5919-C06A-C7CD-9D90B6DC7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A05219-2921-16B3-3391-4EC5FA1E8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E86C2E-DE4E-2B1D-984E-C52687639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777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17DB15-6599-2B70-98C4-1D107F1E0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2BE2A5-27A3-16DA-46CA-A618C9000D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21A569-11A8-2345-5FA6-0C6A88A494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969931-9006-AE4D-C820-B3C6707F80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72A29F-C27C-BB84-1B8D-484080BB1F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E86439-2552-FCFB-BF48-B7A5674E3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DF705C-88B3-DC38-54B2-29CC9FC6E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D9DED9-EA2C-A356-6103-D6CC8102E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969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BEE3B-3D6C-4F90-0259-71C2D3851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1E7A98-F432-5408-D419-2BB47626C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43E0BD-A241-0395-97D8-0B84FC391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CBD541-EFD9-6173-3FED-FEC80C7A5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4619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B5BAE2-4D68-ABCE-18DF-6FFE3BBAF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95EF0F-7117-92AE-E9C3-1B1200CB0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DCCD47-63D7-7663-4F60-D133F18CC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5207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9A5F46-F371-40E0-7E70-5DCEA189A8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ADF83D-A2AC-F60E-1986-7711A793B4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C06691-B0C8-5898-148E-E6D83D1AB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656A28-D607-5DB1-92AB-C445BAFB2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CE041E-D678-738A-EA98-BB33485A6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654E3F-1669-1135-C7FC-2C21BF3E6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8716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B3F7F-75F6-3272-E3BF-DA0E74E73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8A9C6E-F8CA-5F73-69E3-6769EF36C9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EC012A-573B-E74B-695A-9C648D7156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E7BA04-08C6-FFE0-0288-CC2B15055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B7B88D-6819-ADE4-0699-363841923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73B31C-94B7-42A5-54D5-E4B2ABDFE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314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8F04F3-B5BC-A4A5-C8AC-E42EFE009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75D1B4-DABB-2D8C-8CAA-B0A42EBE10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718DE9-A253-5AD7-2950-02452D1805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3692CC-9CC3-41F3-90D5-BFA1FFA9DD5D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D19EFE-B199-A4AE-0295-247D956642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59DB38-F684-CE3E-AD52-FD05FA4F30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5D0E6A-8A1F-484D-A621-B06BA8ECD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7399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78AA66A-31C7-C589-7846-9EF533CEFC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0615956"/>
              </p:ext>
            </p:extLst>
          </p:nvPr>
        </p:nvGraphicFramePr>
        <p:xfrm>
          <a:off x="4617410" y="851626"/>
          <a:ext cx="2706924" cy="4855549"/>
        </p:xfrm>
        <a:graphic>
          <a:graphicData uri="http://schemas.openxmlformats.org/drawingml/2006/table">
            <a:tbl>
              <a:tblPr firstRow="1" firstCol="1" bandRow="1"/>
              <a:tblGrid>
                <a:gridCol w="465882">
                  <a:extLst>
                    <a:ext uri="{9D8B030D-6E8A-4147-A177-3AD203B41FA5}">
                      <a16:colId xmlns:a16="http://schemas.microsoft.com/office/drawing/2014/main" val="356703882"/>
                    </a:ext>
                  </a:extLst>
                </a:gridCol>
                <a:gridCol w="528400">
                  <a:extLst>
                    <a:ext uri="{9D8B030D-6E8A-4147-A177-3AD203B41FA5}">
                      <a16:colId xmlns:a16="http://schemas.microsoft.com/office/drawing/2014/main" val="1855791512"/>
                    </a:ext>
                  </a:extLst>
                </a:gridCol>
                <a:gridCol w="579196">
                  <a:extLst>
                    <a:ext uri="{9D8B030D-6E8A-4147-A177-3AD203B41FA5}">
                      <a16:colId xmlns:a16="http://schemas.microsoft.com/office/drawing/2014/main" val="1690006831"/>
                    </a:ext>
                  </a:extLst>
                </a:gridCol>
                <a:gridCol w="584006">
                  <a:extLst>
                    <a:ext uri="{9D8B030D-6E8A-4147-A177-3AD203B41FA5}">
                      <a16:colId xmlns:a16="http://schemas.microsoft.com/office/drawing/2014/main" val="205979890"/>
                    </a:ext>
                  </a:extLst>
                </a:gridCol>
                <a:gridCol w="549440">
                  <a:extLst>
                    <a:ext uri="{9D8B030D-6E8A-4147-A177-3AD203B41FA5}">
                      <a16:colId xmlns:a16="http://schemas.microsoft.com/office/drawing/2014/main" val="2651715248"/>
                    </a:ext>
                  </a:extLst>
                </a:gridCol>
              </a:tblGrid>
              <a:tr h="97149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Histological Subtype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High Grade Serous </a:t>
                      </a: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62%) n=122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HGSOC, HGSOC (TCC like) or endo adeno/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squamous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Endometrioid </a:t>
                      </a: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21%) n=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2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Endometrioid, Endometrioid with sertoliform pattern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Clear Cell </a:t>
                      </a: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9%) n=18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Other </a:t>
                      </a: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8%) n=16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(Mucinous, Adult granulosa cell carcinoma, Carcinosarcoma, Dysgerminoma, Sex cord stromal tumour, Granulosa cell tumour, Mixed sex cord stromal tumour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9524743"/>
                  </a:ext>
                </a:extLst>
              </a:tr>
              <a:tr h="90171"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Age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7432070"/>
                  </a:ext>
                </a:extLst>
              </a:tr>
              <a:tr h="1515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Median age (years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2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2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55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solidFill>
                            <a:srgbClr val="212121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57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6367029"/>
                  </a:ext>
                </a:extLst>
              </a:tr>
              <a:tr h="90171"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Grade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6690353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% (4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1% (13/4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% (1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8% (6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1028035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6% (20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8% (16/4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1% (2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9% (3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7554479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80% (96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1% (9/4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2% (13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1% (5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894644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Unknown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% (4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0% (4/4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1% (2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3% (2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6851001"/>
                  </a:ext>
                </a:extLst>
              </a:tr>
              <a:tr h="90171"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Stage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9152055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I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% (8/12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3% (18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8% (5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1% (5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7491553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II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3% (16/12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2% (9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7% (3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5% (4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4247016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III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0% (85/12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3% (14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5% (8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1% (5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4155933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IV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1% (13/122) 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% (1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1% (2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3% (2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1362846"/>
                  </a:ext>
                </a:extLst>
              </a:tr>
              <a:tr h="27682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adiation Therapy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% (3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98% (119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: 5% (1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95% (40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0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 100% (18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 0% (0/0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00% (16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6468120"/>
                  </a:ext>
                </a:extLst>
              </a:tr>
              <a:tr h="27682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Platinum Therapy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98% (120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% (2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93% (39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% (3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94% (17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% (1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Ye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88% (14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2% (2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2553150"/>
                  </a:ext>
                </a:extLst>
              </a:tr>
              <a:tr h="9614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Platinum Resistance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Ful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0% (74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Partia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% (9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fractory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% (1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sistant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5% (6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Unknown: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 26% (32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Ful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4% (31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Partia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fractory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sistant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Unknown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26% (11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Ful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1% (11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Partia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fractory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7% (3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sistant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% (1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Unknown: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 17% (3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Ful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8% (6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Partial sens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% (1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fractory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Resistant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Unknown: </a:t>
                      </a: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56% (9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748621"/>
                  </a:ext>
                </a:extLst>
              </a:tr>
              <a:tr h="90171"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HRD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9323920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HRD+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8% (58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9% (8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 17% (3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% (1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8015057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HRD-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8% (58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4% (31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 67% (12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94% (15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0704516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t Tested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5% (6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% (3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7% (3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1907813"/>
                  </a:ext>
                </a:extLst>
              </a:tr>
              <a:tr h="90171"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BRCA status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828470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BRCAwt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7% (57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4% (31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3% (6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63% (10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3873232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BRCAm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2% (14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7% (3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1% (1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0% (0/16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5447723"/>
                  </a:ext>
                </a:extLst>
              </a:tr>
              <a:tr h="901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Not Tested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42% (51/12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19% (8/42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56% (10/18)</a:t>
                      </a:r>
                      <a:endParaRPr lang="en-GB" sz="5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5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Aptos" panose="020B0004020202020204" pitchFamily="34" charset="0"/>
                        </a:rPr>
                        <a:t>38% (6/16)</a:t>
                      </a:r>
                      <a:endParaRPr lang="en-GB" sz="500" kern="100" dirty="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32461" marR="3246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39947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9DEA865-87DC-5CBF-DEC5-18ACFB7D3E5D}"/>
              </a:ext>
            </a:extLst>
          </p:cNvPr>
          <p:cNvSpPr txBox="1"/>
          <p:nvPr/>
        </p:nvSpPr>
        <p:spPr>
          <a:xfrm>
            <a:off x="459607" y="916336"/>
            <a:ext cx="3515627" cy="1857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1:</a:t>
            </a:r>
            <a:r>
              <a:rPr lang="en-GB" sz="18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Patient demographics including age, histological subtype, grade, stage, radiation or platinum therapy, platinum resistance, HRD and BRCA status.</a:t>
            </a:r>
            <a:endParaRPr lang="en-GB" sz="18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4437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91</Words>
  <Application>Microsoft Office PowerPoint</Application>
  <PresentationFormat>Widescreen</PresentationFormat>
  <Paragraphs>1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2:50:35Z</dcterms:created>
  <dcterms:modified xsi:type="dcterms:W3CDTF">2025-10-30T16:17:17Z</dcterms:modified>
</cp:coreProperties>
</file>